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239625" cy="7199313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268" userDrawn="1">
          <p15:clr>
            <a:srgbClr val="A4A3A4"/>
          </p15:clr>
        </p15:guide>
        <p15:guide id="2" pos="9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1" d="100"/>
          <a:sy n="81" d="100"/>
        </p:scale>
        <p:origin x="-90" y="-480"/>
      </p:cViewPr>
      <p:guideLst>
        <p:guide orient="horz" pos="2993"/>
        <p:guide pos="60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7972" y="2236458"/>
            <a:ext cx="10403682" cy="154318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35945" y="4079611"/>
            <a:ext cx="8567738" cy="183982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885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771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657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542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428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314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2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085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1A80D-DDBA-4797-BE1F-C1E0326DF965}" type="datetimeFigureOut">
              <a:rPr lang="nl-BE" smtClean="0"/>
              <a:t>12/01/2018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59802-96CB-4836-B163-885249DCA3D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54072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1A80D-DDBA-4797-BE1F-C1E0326DF965}" type="datetimeFigureOut">
              <a:rPr lang="nl-BE" smtClean="0"/>
              <a:t>12/01/2018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59802-96CB-4836-B163-885249DCA3D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0015179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482307" y="288308"/>
            <a:ext cx="3253274" cy="614274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22478" y="288308"/>
            <a:ext cx="9555833" cy="614274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1A80D-DDBA-4797-BE1F-C1E0326DF965}" type="datetimeFigureOut">
              <a:rPr lang="nl-BE" smtClean="0"/>
              <a:t>12/01/2018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59802-96CB-4836-B163-885249DCA3D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506357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1A80D-DDBA-4797-BE1F-C1E0326DF965}" type="datetimeFigureOut">
              <a:rPr lang="nl-BE" smtClean="0"/>
              <a:t>12/01/2018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59802-96CB-4836-B163-885249DCA3D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695675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6846" y="4626230"/>
            <a:ext cx="10403682" cy="1429864"/>
          </a:xfrm>
        </p:spPr>
        <p:txBody>
          <a:bodyPr anchor="t"/>
          <a:lstStyle>
            <a:lvl1pPr algn="l">
              <a:defRPr sz="3400" b="1" cap="all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6846" y="3051377"/>
            <a:ext cx="10403682" cy="1574849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88574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2pPr>
            <a:lvl3pPr marL="777149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3pPr>
            <a:lvl4pPr marL="1165723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4pPr>
            <a:lvl5pPr marL="1554297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5pPr>
            <a:lvl6pPr marL="1942871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6pPr>
            <a:lvl7pPr marL="2331446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7pPr>
            <a:lvl8pPr marL="272002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8pPr>
            <a:lvl9pPr marL="3108594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1A80D-DDBA-4797-BE1F-C1E0326DF965}" type="datetimeFigureOut">
              <a:rPr lang="nl-BE" smtClean="0"/>
              <a:t>12/01/2018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59802-96CB-4836-B163-885249DCA3D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427544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22480" y="1679844"/>
            <a:ext cx="6404553" cy="4751214"/>
          </a:xfrm>
        </p:spPr>
        <p:txBody>
          <a:bodyPr/>
          <a:lstStyle>
            <a:lvl1pPr>
              <a:defRPr sz="2380"/>
            </a:lvl1pPr>
            <a:lvl2pPr>
              <a:defRPr sz="2040"/>
            </a:lvl2pPr>
            <a:lvl3pPr>
              <a:defRPr sz="1700"/>
            </a:lvl3pPr>
            <a:lvl4pPr>
              <a:defRPr sz="1530"/>
            </a:lvl4pPr>
            <a:lvl5pPr>
              <a:defRPr sz="1530"/>
            </a:lvl5pPr>
            <a:lvl6pPr>
              <a:defRPr sz="1530"/>
            </a:lvl6pPr>
            <a:lvl7pPr>
              <a:defRPr sz="1530"/>
            </a:lvl7pPr>
            <a:lvl8pPr>
              <a:defRPr sz="1530"/>
            </a:lvl8pPr>
            <a:lvl9pPr>
              <a:defRPr sz="153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331027" y="1679844"/>
            <a:ext cx="6404553" cy="4751214"/>
          </a:xfrm>
        </p:spPr>
        <p:txBody>
          <a:bodyPr/>
          <a:lstStyle>
            <a:lvl1pPr>
              <a:defRPr sz="2380"/>
            </a:lvl1pPr>
            <a:lvl2pPr>
              <a:defRPr sz="2040"/>
            </a:lvl2pPr>
            <a:lvl3pPr>
              <a:defRPr sz="1700"/>
            </a:lvl3pPr>
            <a:lvl4pPr>
              <a:defRPr sz="1530"/>
            </a:lvl4pPr>
            <a:lvl5pPr>
              <a:defRPr sz="1530"/>
            </a:lvl5pPr>
            <a:lvl6pPr>
              <a:defRPr sz="1530"/>
            </a:lvl6pPr>
            <a:lvl7pPr>
              <a:defRPr sz="1530"/>
            </a:lvl7pPr>
            <a:lvl8pPr>
              <a:defRPr sz="1530"/>
            </a:lvl8pPr>
            <a:lvl9pPr>
              <a:defRPr sz="153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1A80D-DDBA-4797-BE1F-C1E0326DF965}" type="datetimeFigureOut">
              <a:rPr lang="nl-BE" smtClean="0"/>
              <a:t>12/01/2018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59802-96CB-4836-B163-885249DCA3D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837022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1983" y="288306"/>
            <a:ext cx="11015663" cy="1199886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1982" y="1611513"/>
            <a:ext cx="5407960" cy="671602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574" indent="0">
              <a:buNone/>
              <a:defRPr sz="1700" b="1"/>
            </a:lvl2pPr>
            <a:lvl3pPr marL="777149" indent="0">
              <a:buNone/>
              <a:defRPr sz="1530" b="1"/>
            </a:lvl3pPr>
            <a:lvl4pPr marL="1165723" indent="0">
              <a:buNone/>
              <a:defRPr sz="1360" b="1"/>
            </a:lvl4pPr>
            <a:lvl5pPr marL="1554297" indent="0">
              <a:buNone/>
              <a:defRPr sz="1360" b="1"/>
            </a:lvl5pPr>
            <a:lvl6pPr marL="1942871" indent="0">
              <a:buNone/>
              <a:defRPr sz="1360" b="1"/>
            </a:lvl6pPr>
            <a:lvl7pPr marL="2331446" indent="0">
              <a:buNone/>
              <a:defRPr sz="1360" b="1"/>
            </a:lvl7pPr>
            <a:lvl8pPr marL="2720020" indent="0">
              <a:buNone/>
              <a:defRPr sz="1360" b="1"/>
            </a:lvl8pPr>
            <a:lvl9pPr marL="3108594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1982" y="2283115"/>
            <a:ext cx="5407960" cy="4147938"/>
          </a:xfrm>
        </p:spPr>
        <p:txBody>
          <a:bodyPr/>
          <a:lstStyle>
            <a:lvl1pPr>
              <a:defRPr sz="2040"/>
            </a:lvl1pPr>
            <a:lvl2pPr>
              <a:defRPr sz="1700"/>
            </a:lvl2pPr>
            <a:lvl3pPr>
              <a:defRPr sz="1530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17562" y="1611513"/>
            <a:ext cx="5410085" cy="671602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574" indent="0">
              <a:buNone/>
              <a:defRPr sz="1700" b="1"/>
            </a:lvl2pPr>
            <a:lvl3pPr marL="777149" indent="0">
              <a:buNone/>
              <a:defRPr sz="1530" b="1"/>
            </a:lvl3pPr>
            <a:lvl4pPr marL="1165723" indent="0">
              <a:buNone/>
              <a:defRPr sz="1360" b="1"/>
            </a:lvl4pPr>
            <a:lvl5pPr marL="1554297" indent="0">
              <a:buNone/>
              <a:defRPr sz="1360" b="1"/>
            </a:lvl5pPr>
            <a:lvl6pPr marL="1942871" indent="0">
              <a:buNone/>
              <a:defRPr sz="1360" b="1"/>
            </a:lvl6pPr>
            <a:lvl7pPr marL="2331446" indent="0">
              <a:buNone/>
              <a:defRPr sz="1360" b="1"/>
            </a:lvl7pPr>
            <a:lvl8pPr marL="2720020" indent="0">
              <a:buNone/>
              <a:defRPr sz="1360" b="1"/>
            </a:lvl8pPr>
            <a:lvl9pPr marL="3108594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562" y="2283115"/>
            <a:ext cx="5410085" cy="4147938"/>
          </a:xfrm>
        </p:spPr>
        <p:txBody>
          <a:bodyPr/>
          <a:lstStyle>
            <a:lvl1pPr>
              <a:defRPr sz="2040"/>
            </a:lvl1pPr>
            <a:lvl2pPr>
              <a:defRPr sz="1700"/>
            </a:lvl2pPr>
            <a:lvl3pPr>
              <a:defRPr sz="1530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1A80D-DDBA-4797-BE1F-C1E0326DF965}" type="datetimeFigureOut">
              <a:rPr lang="nl-BE" smtClean="0"/>
              <a:t>12/01/2018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59802-96CB-4836-B163-885249DCA3D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595395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1A80D-DDBA-4797-BE1F-C1E0326DF965}" type="datetimeFigureOut">
              <a:rPr lang="nl-BE" smtClean="0"/>
              <a:t>12/01/2018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59802-96CB-4836-B163-885249DCA3D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512871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1A80D-DDBA-4797-BE1F-C1E0326DF965}" type="datetimeFigureOut">
              <a:rPr lang="nl-BE" smtClean="0"/>
              <a:t>12/01/2018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59802-96CB-4836-B163-885249DCA3D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58759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1984" y="286639"/>
            <a:ext cx="4026752" cy="1219884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85355" y="286642"/>
            <a:ext cx="6842290" cy="6144414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1984" y="1506525"/>
            <a:ext cx="4026752" cy="4924531"/>
          </a:xfrm>
        </p:spPr>
        <p:txBody>
          <a:bodyPr/>
          <a:lstStyle>
            <a:lvl1pPr marL="0" indent="0">
              <a:buNone/>
              <a:defRPr sz="1190"/>
            </a:lvl1pPr>
            <a:lvl2pPr marL="388574" indent="0">
              <a:buNone/>
              <a:defRPr sz="1020"/>
            </a:lvl2pPr>
            <a:lvl3pPr marL="777149" indent="0">
              <a:buNone/>
              <a:defRPr sz="850"/>
            </a:lvl3pPr>
            <a:lvl4pPr marL="1165723" indent="0">
              <a:buNone/>
              <a:defRPr sz="765"/>
            </a:lvl4pPr>
            <a:lvl5pPr marL="1554297" indent="0">
              <a:buNone/>
              <a:defRPr sz="765"/>
            </a:lvl5pPr>
            <a:lvl6pPr marL="1942871" indent="0">
              <a:buNone/>
              <a:defRPr sz="765"/>
            </a:lvl6pPr>
            <a:lvl7pPr marL="2331446" indent="0">
              <a:buNone/>
              <a:defRPr sz="765"/>
            </a:lvl7pPr>
            <a:lvl8pPr marL="2720020" indent="0">
              <a:buNone/>
              <a:defRPr sz="765"/>
            </a:lvl8pPr>
            <a:lvl9pPr marL="3108594" indent="0">
              <a:buNone/>
              <a:defRPr sz="76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1A80D-DDBA-4797-BE1F-C1E0326DF965}" type="datetimeFigureOut">
              <a:rPr lang="nl-BE" smtClean="0"/>
              <a:t>12/01/2018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59802-96CB-4836-B163-885249DCA3D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539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99053" y="5039519"/>
            <a:ext cx="7343775" cy="594944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99053" y="643272"/>
            <a:ext cx="7343775" cy="4319588"/>
          </a:xfrm>
        </p:spPr>
        <p:txBody>
          <a:bodyPr/>
          <a:lstStyle>
            <a:lvl1pPr marL="0" indent="0">
              <a:buNone/>
              <a:defRPr sz="2720"/>
            </a:lvl1pPr>
            <a:lvl2pPr marL="388574" indent="0">
              <a:buNone/>
              <a:defRPr sz="2380"/>
            </a:lvl2pPr>
            <a:lvl3pPr marL="777149" indent="0">
              <a:buNone/>
              <a:defRPr sz="2040"/>
            </a:lvl3pPr>
            <a:lvl4pPr marL="1165723" indent="0">
              <a:buNone/>
              <a:defRPr sz="1700"/>
            </a:lvl4pPr>
            <a:lvl5pPr marL="1554297" indent="0">
              <a:buNone/>
              <a:defRPr sz="1700"/>
            </a:lvl5pPr>
            <a:lvl6pPr marL="1942871" indent="0">
              <a:buNone/>
              <a:defRPr sz="1700"/>
            </a:lvl6pPr>
            <a:lvl7pPr marL="2331446" indent="0">
              <a:buNone/>
              <a:defRPr sz="1700"/>
            </a:lvl7pPr>
            <a:lvl8pPr marL="2720020" indent="0">
              <a:buNone/>
              <a:defRPr sz="1700"/>
            </a:lvl8pPr>
            <a:lvl9pPr marL="3108594" indent="0">
              <a:buNone/>
              <a:defRPr sz="1700"/>
            </a:lvl9pPr>
          </a:lstStyle>
          <a:p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99053" y="5634463"/>
            <a:ext cx="7343775" cy="844919"/>
          </a:xfrm>
        </p:spPr>
        <p:txBody>
          <a:bodyPr/>
          <a:lstStyle>
            <a:lvl1pPr marL="0" indent="0">
              <a:buNone/>
              <a:defRPr sz="1190"/>
            </a:lvl1pPr>
            <a:lvl2pPr marL="388574" indent="0">
              <a:buNone/>
              <a:defRPr sz="1020"/>
            </a:lvl2pPr>
            <a:lvl3pPr marL="777149" indent="0">
              <a:buNone/>
              <a:defRPr sz="850"/>
            </a:lvl3pPr>
            <a:lvl4pPr marL="1165723" indent="0">
              <a:buNone/>
              <a:defRPr sz="765"/>
            </a:lvl4pPr>
            <a:lvl5pPr marL="1554297" indent="0">
              <a:buNone/>
              <a:defRPr sz="765"/>
            </a:lvl5pPr>
            <a:lvl6pPr marL="1942871" indent="0">
              <a:buNone/>
              <a:defRPr sz="765"/>
            </a:lvl6pPr>
            <a:lvl7pPr marL="2331446" indent="0">
              <a:buNone/>
              <a:defRPr sz="765"/>
            </a:lvl7pPr>
            <a:lvl8pPr marL="2720020" indent="0">
              <a:buNone/>
              <a:defRPr sz="765"/>
            </a:lvl8pPr>
            <a:lvl9pPr marL="3108594" indent="0">
              <a:buNone/>
              <a:defRPr sz="76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1A80D-DDBA-4797-BE1F-C1E0326DF965}" type="datetimeFigureOut">
              <a:rPr lang="nl-BE" smtClean="0"/>
              <a:t>12/01/2018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59802-96CB-4836-B163-885249DCA3D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5468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1983" y="288306"/>
            <a:ext cx="11015663" cy="11998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1983" y="1679844"/>
            <a:ext cx="11015663" cy="47512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1982" y="6672701"/>
            <a:ext cx="2855913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61A80D-DDBA-4797-BE1F-C1E0326DF965}" type="datetimeFigureOut">
              <a:rPr lang="nl-BE" smtClean="0"/>
              <a:t>12/01/2018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81873" y="6672701"/>
            <a:ext cx="3875881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71733" y="6672701"/>
            <a:ext cx="2855913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159802-96CB-4836-B163-885249DCA3D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860151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77149" rtl="0" eaLnBrk="1" latinLnBrk="0" hangingPunct="1"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1431" indent="-291431" algn="l" defTabSz="777149" rtl="0" eaLnBrk="1" latinLnBrk="0" hangingPunct="1">
        <a:spcBef>
          <a:spcPct val="20000"/>
        </a:spcBef>
        <a:buFont typeface="Arial" panose="020B0604020202020204" pitchFamily="34" charset="0"/>
        <a:buChar char="•"/>
        <a:defRPr sz="2720" kern="1200">
          <a:solidFill>
            <a:schemeClr val="tx1"/>
          </a:solidFill>
          <a:latin typeface="+mn-lt"/>
          <a:ea typeface="+mn-ea"/>
          <a:cs typeface="+mn-cs"/>
        </a:defRPr>
      </a:lvl1pPr>
      <a:lvl2pPr marL="631433" indent="-242859" algn="l" defTabSz="777149" rtl="0" eaLnBrk="1" latinLnBrk="0" hangingPunct="1">
        <a:spcBef>
          <a:spcPct val="20000"/>
        </a:spcBef>
        <a:buFont typeface="Arial" panose="020B0604020202020204" pitchFamily="34" charset="0"/>
        <a:buChar char="–"/>
        <a:defRPr sz="2380" kern="1200">
          <a:solidFill>
            <a:schemeClr val="tx1"/>
          </a:solidFill>
          <a:latin typeface="+mn-lt"/>
          <a:ea typeface="+mn-ea"/>
          <a:cs typeface="+mn-cs"/>
        </a:defRPr>
      </a:lvl2pPr>
      <a:lvl3pPr marL="971436" indent="-194287" algn="l" defTabSz="777149" rtl="0" eaLnBrk="1" latinLnBrk="0" hangingPunct="1">
        <a:spcBef>
          <a:spcPct val="20000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3pPr>
      <a:lvl4pPr marL="1360010" indent="-194287" algn="l" defTabSz="777149" rtl="0" eaLnBrk="1" latinLnBrk="0" hangingPunct="1">
        <a:spcBef>
          <a:spcPct val="20000"/>
        </a:spcBef>
        <a:buFont typeface="Arial" panose="020B0604020202020204" pitchFamily="34" charset="0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48584" indent="-194287" algn="l" defTabSz="777149" rtl="0" eaLnBrk="1" latinLnBrk="0" hangingPunct="1">
        <a:spcBef>
          <a:spcPct val="20000"/>
        </a:spcBef>
        <a:buFont typeface="Arial" panose="020B0604020202020204" pitchFamily="34" charset="0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37159" indent="-194287" algn="l" defTabSz="777149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25733" indent="-194287" algn="l" defTabSz="777149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14307" indent="-194287" algn="l" defTabSz="777149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02881" indent="-194287" algn="l" defTabSz="777149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77714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574" algn="l" defTabSz="77714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149" algn="l" defTabSz="77714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723" algn="l" defTabSz="77714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297" algn="l" defTabSz="77714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2871" algn="l" defTabSz="77714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446" algn="l" defTabSz="77714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020" algn="l" defTabSz="77714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594" algn="l" defTabSz="777149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03188" y="5183832"/>
            <a:ext cx="1144927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. Scatter plots displaying the association between individual differences in FA in right ILF (depicted on the X-axis) and individual differences in quantitative ASD characteristics and visual processing measures 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(depicte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on the Y-axis). 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First row: Associations with (square root transformed) scores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on the SRS questionnaire, the SRS Social and Communication subscale, the SRS RRBI subscale, and the RBS-R 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questionnaire. Second row: Associations with reaction time on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he Fragmented Object Outlines task, 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(log-transformed) percentage coherence threshol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on the Coherent Motion Task, (log-transformed) 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eaction time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on the Visual Search task, and 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(square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root 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ransformed) fragmentation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score on the Rey-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Osterrieth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Complex Figure 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ask. ASD subjects are depicted by empty squares, TD subjects by filled diamonds. </a:t>
            </a:r>
            <a:endParaRPr lang="nl-B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7525" y="143272"/>
            <a:ext cx="2700300" cy="243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2411" y="143272"/>
            <a:ext cx="2589089" cy="243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9035" y="143272"/>
            <a:ext cx="2661097" cy="243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7347" y="143272"/>
            <a:ext cx="2661097" cy="243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8219" y="2745432"/>
            <a:ext cx="2563281" cy="243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7525" y="2745432"/>
            <a:ext cx="2700299" cy="243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42235" y="2745432"/>
            <a:ext cx="2729906" cy="243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7347" y="2745432"/>
            <a:ext cx="2661097" cy="243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900706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98</TotalTime>
  <Words>138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.U.Leuv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ets Bart</dc:creator>
  <cp:lastModifiedBy>Balindan, Danica Joy</cp:lastModifiedBy>
  <cp:revision>13</cp:revision>
  <dcterms:created xsi:type="dcterms:W3CDTF">2017-01-05T20:37:45Z</dcterms:created>
  <dcterms:modified xsi:type="dcterms:W3CDTF">2018-01-11T16:43:00Z</dcterms:modified>
</cp:coreProperties>
</file>